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handoutMasterIdLst>
    <p:handoutMasterId r:id="rId12"/>
  </p:handoutMasterIdLst>
  <p:sldIdLst>
    <p:sldId id="275" r:id="rId2"/>
    <p:sldId id="282" r:id="rId3"/>
    <p:sldId id="276" r:id="rId4"/>
    <p:sldId id="277" r:id="rId5"/>
    <p:sldId id="278" r:id="rId6"/>
    <p:sldId id="279" r:id="rId7"/>
    <p:sldId id="283" r:id="rId8"/>
    <p:sldId id="280" r:id="rId9"/>
    <p:sldId id="281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F5DBEF"/>
    <a:srgbClr val="F1CFE9"/>
    <a:srgbClr val="B63797"/>
    <a:srgbClr val="E06563"/>
    <a:srgbClr val="6A00A8"/>
    <a:srgbClr val="FCA7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61" autoAdjust="0"/>
    <p:restoredTop sz="96173" autoAdjust="0"/>
  </p:normalViewPr>
  <p:slideViewPr>
    <p:cSldViewPr snapToGrid="0">
      <p:cViewPr varScale="1">
        <p:scale>
          <a:sx n="76" d="100"/>
          <a:sy n="76" d="100"/>
        </p:scale>
        <p:origin x="822" y="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88" d="100"/>
          <a:sy n="88" d="100"/>
        </p:scale>
        <p:origin x="3822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image" Target="../media/image41.emf"/><Relationship Id="rId4" Type="http://schemas.openxmlformats.org/officeDocument/2006/relationships/image" Target="../media/image4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F3111F-7010-4429-B9DA-01C7E62350A8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0C7B4D-C7AF-4D5E-82E4-5813E090A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1385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85D219-777A-472F-9C78-320646408CDB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32B52D-FB18-4AA1-9B61-DC41F3CB5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8530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GB" b="1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0707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8558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2083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20168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02347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2118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32B52D-FB18-4AA1-9B61-DC41F3CB5AA7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1355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184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921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089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0157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232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649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81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880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542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535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193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A552BC-39DC-44F8-B9A8-B84CCF92F249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F61BD-079B-44A9-98E4-8CC02729C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963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7.png"/><Relationship Id="rId7" Type="http://schemas.openxmlformats.org/officeDocument/2006/relationships/oleObject" Target="../embeddings/oleObject1.bin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19" Type="http://schemas.openxmlformats.org/officeDocument/2006/relationships/image" Target="../media/image15.png"/><Relationship Id="rId4" Type="http://schemas.openxmlformats.org/officeDocument/2006/relationships/image" Target="../media/image2.png"/><Relationship Id="rId9" Type="http://schemas.openxmlformats.org/officeDocument/2006/relationships/image" Target="../media/image5.tiff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tiff"/><Relationship Id="rId13" Type="http://schemas.openxmlformats.org/officeDocument/2006/relationships/image" Target="../media/image18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2.tiff"/><Relationship Id="rId12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1.tiff"/><Relationship Id="rId11" Type="http://schemas.openxmlformats.org/officeDocument/2006/relationships/image" Target="../media/image26.tiff"/><Relationship Id="rId5" Type="http://schemas.openxmlformats.org/officeDocument/2006/relationships/image" Target="../media/image20.tiff"/><Relationship Id="rId10" Type="http://schemas.openxmlformats.org/officeDocument/2006/relationships/image" Target="../media/image25.tiff"/><Relationship Id="rId4" Type="http://schemas.openxmlformats.org/officeDocument/2006/relationships/image" Target="../media/image19.tiff"/><Relationship Id="rId9" Type="http://schemas.openxmlformats.org/officeDocument/2006/relationships/image" Target="../media/image24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9.png"/><Relationship Id="rId4" Type="http://schemas.openxmlformats.org/officeDocument/2006/relationships/image" Target="../media/image28.png"/><Relationship Id="rId9" Type="http://schemas.openxmlformats.org/officeDocument/2006/relationships/image" Target="../media/image3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32.emf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36.png"/><Relationship Id="rId12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13" Type="http://schemas.openxmlformats.org/officeDocument/2006/relationships/image" Target="../media/image50.png"/><Relationship Id="rId18" Type="http://schemas.openxmlformats.org/officeDocument/2006/relationships/oleObject" Target="../embeddings/oleObject8.bin"/><Relationship Id="rId26" Type="http://schemas.openxmlformats.org/officeDocument/2006/relationships/image" Target="../media/image59.png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54.png"/><Relationship Id="rId7" Type="http://schemas.openxmlformats.org/officeDocument/2006/relationships/image" Target="../media/image42.emf"/><Relationship Id="rId12" Type="http://schemas.openxmlformats.org/officeDocument/2006/relationships/image" Target="../media/image49.png"/><Relationship Id="rId17" Type="http://schemas.openxmlformats.org/officeDocument/2006/relationships/image" Target="../media/image43.emf"/><Relationship Id="rId25" Type="http://schemas.openxmlformats.org/officeDocument/2006/relationships/image" Target="../media/image58.png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image" Target="../media/image53.png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48.png"/><Relationship Id="rId24" Type="http://schemas.openxmlformats.org/officeDocument/2006/relationships/image" Target="../media/image57.png"/><Relationship Id="rId5" Type="http://schemas.openxmlformats.org/officeDocument/2006/relationships/image" Target="../media/image41.emf"/><Relationship Id="rId15" Type="http://schemas.openxmlformats.org/officeDocument/2006/relationships/image" Target="../media/image52.png"/><Relationship Id="rId23" Type="http://schemas.openxmlformats.org/officeDocument/2006/relationships/image" Target="../media/image56.png"/><Relationship Id="rId10" Type="http://schemas.openxmlformats.org/officeDocument/2006/relationships/image" Target="../media/image47.png"/><Relationship Id="rId19" Type="http://schemas.openxmlformats.org/officeDocument/2006/relationships/image" Target="../media/image44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46.png"/><Relationship Id="rId14" Type="http://schemas.openxmlformats.org/officeDocument/2006/relationships/image" Target="../media/image51.png"/><Relationship Id="rId22" Type="http://schemas.openxmlformats.org/officeDocument/2006/relationships/image" Target="../media/image55.png"/><Relationship Id="rId27" Type="http://schemas.openxmlformats.org/officeDocument/2006/relationships/image" Target="../media/image60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38072" y="506785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38072" y="1936891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c</a:t>
            </a:r>
            <a:endParaRPr lang="en-GB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80682" y="1125774"/>
            <a:ext cx="6961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Generate EBs from mESC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01774" y="1125773"/>
            <a:ext cx="8309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Sort </a:t>
            </a:r>
          </a:p>
          <a:p>
            <a:pPr algn="ctr"/>
            <a:r>
              <a:rPr lang="en-GB" sz="800" dirty="0"/>
              <a:t>TIE2+ FLK1+ population</a:t>
            </a:r>
          </a:p>
        </p:txBody>
      </p:sp>
      <p:cxnSp>
        <p:nvCxnSpPr>
          <p:cNvPr id="21" name="Straight Connector 20"/>
          <p:cNvCxnSpPr/>
          <p:nvPr/>
        </p:nvCxnSpPr>
        <p:spPr>
          <a:xfrm>
            <a:off x="598546" y="1026540"/>
            <a:ext cx="333413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603741" y="1026540"/>
            <a:ext cx="0" cy="628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317236" y="1025008"/>
            <a:ext cx="0" cy="628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325160" y="1024042"/>
            <a:ext cx="0" cy="628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08462" y="1032669"/>
            <a:ext cx="1905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/>
              <a:t>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224597" y="1035800"/>
            <a:ext cx="1905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/>
              <a:t>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227624" y="1032669"/>
            <a:ext cx="1905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/>
              <a:t>7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3930028" y="1024042"/>
            <a:ext cx="0" cy="628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785079" y="1048354"/>
            <a:ext cx="2898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/>
              <a:t>28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322902" y="751574"/>
            <a:ext cx="1607125" cy="10956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30" name="TextBox 29"/>
          <p:cNvSpPr txBox="1"/>
          <p:nvPr/>
        </p:nvSpPr>
        <p:spPr>
          <a:xfrm>
            <a:off x="1941405" y="1120732"/>
            <a:ext cx="762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Start analysis</a:t>
            </a:r>
          </a:p>
          <a:p>
            <a:pPr algn="ctr"/>
            <a:r>
              <a:rPr lang="en-GB" sz="800" dirty="0"/>
              <a:t>+/- dox</a:t>
            </a:r>
          </a:p>
        </p:txBody>
      </p:sp>
      <p:sp>
        <p:nvSpPr>
          <p:cNvPr id="43" name="Rectangle 42"/>
          <p:cNvSpPr/>
          <p:nvPr/>
        </p:nvSpPr>
        <p:spPr>
          <a:xfrm>
            <a:off x="1332379" y="887035"/>
            <a:ext cx="2604959" cy="109561"/>
          </a:xfrm>
          <a:prstGeom prst="rect">
            <a:avLst/>
          </a:prstGeom>
          <a:solidFill>
            <a:srgbClr val="F5DBE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4" name="Rectangle 43"/>
          <p:cNvSpPr/>
          <p:nvPr/>
        </p:nvSpPr>
        <p:spPr>
          <a:xfrm>
            <a:off x="605856" y="887035"/>
            <a:ext cx="718690" cy="10956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5" name="TextBox 44"/>
          <p:cNvSpPr txBox="1"/>
          <p:nvPr/>
        </p:nvSpPr>
        <p:spPr>
          <a:xfrm>
            <a:off x="2142556" y="699309"/>
            <a:ext cx="762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alysis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245194" y="832910"/>
            <a:ext cx="1152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Endothelial cell culture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99467" y="837513"/>
            <a:ext cx="663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EB cultur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405173" y="501558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764007" y="1943392"/>
            <a:ext cx="244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d</a:t>
            </a:r>
            <a:endParaRPr lang="en-GB" sz="1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2948613" y="2018554"/>
            <a:ext cx="2766338" cy="1621412"/>
            <a:chOff x="2920394" y="1995224"/>
            <a:chExt cx="2462930" cy="1462942"/>
          </a:xfrm>
        </p:grpSpPr>
        <p:grpSp>
          <p:nvGrpSpPr>
            <p:cNvPr id="36" name="Group 35"/>
            <p:cNvGrpSpPr/>
            <p:nvPr/>
          </p:nvGrpSpPr>
          <p:grpSpPr>
            <a:xfrm>
              <a:off x="3117072" y="2245039"/>
              <a:ext cx="1066665" cy="1026480"/>
              <a:chOff x="2374451" y="950878"/>
              <a:chExt cx="7055299" cy="4804628"/>
            </a:xfrm>
          </p:grpSpPr>
          <p:cxnSp>
            <p:nvCxnSpPr>
              <p:cNvPr id="37" name="Straight Arrow Connector 36"/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TextBox 41"/>
            <p:cNvSpPr txBox="1"/>
            <p:nvPr/>
          </p:nvSpPr>
          <p:spPr>
            <a:xfrm rot="16200000">
              <a:off x="2647607" y="2653238"/>
              <a:ext cx="771642" cy="2260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FLK1-PECy7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377408" y="3229067"/>
              <a:ext cx="562372" cy="229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TIE2-PE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3719498" y="2625008"/>
              <a:ext cx="1066794" cy="2260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VE-Cadherin-APC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309476" y="3228527"/>
              <a:ext cx="1056102" cy="229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CD31-PerCP Cy5.5</a:t>
              </a: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4316659" y="2237663"/>
              <a:ext cx="1066665" cy="1034019"/>
              <a:chOff x="2374451" y="950878"/>
              <a:chExt cx="7055299" cy="4804628"/>
            </a:xfrm>
          </p:grpSpPr>
          <p:cxnSp>
            <p:nvCxnSpPr>
              <p:cNvPr id="52" name="Straight Arrow Connector 51"/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6" name="TextBox 55"/>
            <p:cNvSpPr txBox="1"/>
            <p:nvPr/>
          </p:nvSpPr>
          <p:spPr>
            <a:xfrm>
              <a:off x="3919520" y="1995224"/>
              <a:ext cx="5713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Day 7</a:t>
              </a:r>
            </a:p>
          </p:txBody>
        </p:sp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81437" y="2238204"/>
              <a:ext cx="1057029" cy="1033234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79756" y="2238204"/>
              <a:ext cx="1057029" cy="1033234"/>
            </a:xfrm>
            <a:prstGeom prst="rect">
              <a:avLst/>
            </a:prstGeom>
          </p:spPr>
        </p:pic>
        <p:cxnSp>
          <p:nvCxnSpPr>
            <p:cNvPr id="61" name="Straight Connector 60"/>
            <p:cNvCxnSpPr/>
            <p:nvPr/>
          </p:nvCxnSpPr>
          <p:spPr>
            <a:xfrm>
              <a:off x="3102326" y="2204644"/>
              <a:ext cx="226553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>
            <a:off x="4629163" y="579891"/>
            <a:ext cx="1600098" cy="1517949"/>
            <a:chOff x="4541632" y="898161"/>
            <a:chExt cx="1889644" cy="1734440"/>
          </a:xfrm>
        </p:grpSpPr>
        <p:grpSp>
          <p:nvGrpSpPr>
            <p:cNvPr id="62" name="Group 61"/>
            <p:cNvGrpSpPr/>
            <p:nvPr/>
          </p:nvGrpSpPr>
          <p:grpSpPr>
            <a:xfrm>
              <a:off x="4850128" y="898161"/>
              <a:ext cx="1475999" cy="1439999"/>
              <a:chOff x="7259019" y="333376"/>
              <a:chExt cx="2321001" cy="2181224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 rotWithShape="1">
              <a:blip r:embed="rId6"/>
              <a:srcRect l="50439" t="49901" r="24498"/>
              <a:stretch/>
            </p:blipFill>
            <p:spPr>
              <a:xfrm>
                <a:off x="7259019" y="333376"/>
                <a:ext cx="2321001" cy="2181224"/>
              </a:xfrm>
              <a:prstGeom prst="rect">
                <a:avLst/>
              </a:prstGeom>
            </p:spPr>
          </p:pic>
          <p:sp>
            <p:nvSpPr>
              <p:cNvPr id="64" name="Rectangle 63"/>
              <p:cNvSpPr/>
              <p:nvPr/>
            </p:nvSpPr>
            <p:spPr>
              <a:xfrm>
                <a:off x="7830108" y="428625"/>
                <a:ext cx="1692000" cy="146685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grpSp>
          <p:nvGrpSpPr>
            <p:cNvPr id="65" name="Group 64"/>
            <p:cNvGrpSpPr/>
            <p:nvPr/>
          </p:nvGrpSpPr>
          <p:grpSpPr>
            <a:xfrm>
              <a:off x="4850128" y="898161"/>
              <a:ext cx="1581148" cy="1439999"/>
              <a:chOff x="2374451" y="950878"/>
              <a:chExt cx="7055299" cy="4804628"/>
            </a:xfrm>
          </p:grpSpPr>
          <p:cxnSp>
            <p:nvCxnSpPr>
              <p:cNvPr id="66" name="Straight Arrow Connector 65"/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/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/>
            <p:cNvSpPr txBox="1"/>
            <p:nvPr/>
          </p:nvSpPr>
          <p:spPr>
            <a:xfrm rot="16200000">
              <a:off x="4206646" y="1479116"/>
              <a:ext cx="969835" cy="299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FLK1-PECy7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232798" y="2288747"/>
              <a:ext cx="890637" cy="343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TIE2-PE</a:t>
              </a:r>
            </a:p>
          </p:txBody>
        </p:sp>
      </p:grpSp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405893" y="5510756"/>
          <a:ext cx="2250045" cy="1964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76" name="Prism 8" r:id="rId7" imgW="3155869" imgH="2755178" progId="Prism8.Document">
                  <p:embed/>
                </p:oleObj>
              </mc:Choice>
              <mc:Fallback>
                <p:oleObj name="Prism 8" r:id="rId7" imgW="3155869" imgH="2755178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5893" y="5510756"/>
                        <a:ext cx="2250045" cy="1964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extBox 53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1</a:t>
            </a: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847" y="2129340"/>
            <a:ext cx="1737017" cy="1348838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273372" y="3720041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e</a:t>
            </a:r>
            <a:endParaRPr lang="en-GB" sz="1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411305" y="4038485"/>
            <a:ext cx="2779171" cy="1419955"/>
            <a:chOff x="2235468" y="3632202"/>
            <a:chExt cx="5108556" cy="2611912"/>
          </a:xfrm>
        </p:grpSpPr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9826F460-54CD-0347-8360-360DA436FB37}"/>
                </a:ext>
              </a:extLst>
            </p:cNvPr>
            <p:cNvGrpSpPr/>
            <p:nvPr/>
          </p:nvGrpSpPr>
          <p:grpSpPr>
            <a:xfrm>
              <a:off x="2638357" y="3640515"/>
              <a:ext cx="4705667" cy="2091651"/>
              <a:chOff x="2374451" y="950878"/>
              <a:chExt cx="7055299" cy="4804628"/>
            </a:xfrm>
          </p:grpSpPr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id="{D2FD5783-AB17-F443-9DD3-25C2EBB9B050}"/>
                  </a:ext>
                </a:extLst>
              </p:cNvPr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72">
                <a:extLst>
                  <a:ext uri="{FF2B5EF4-FFF2-40B4-BE49-F238E27FC236}">
                    <a16:creationId xmlns:a16="http://schemas.microsoft.com/office/drawing/2014/main" id="{FA41A0F5-DE36-284F-9D86-BD338CA78DAD}"/>
                  </a:ext>
                </a:extLst>
              </p:cNvPr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73"/>
            <p:cNvSpPr txBox="1"/>
            <p:nvPr/>
          </p:nvSpPr>
          <p:spPr>
            <a:xfrm>
              <a:off x="4451220" y="5732570"/>
              <a:ext cx="1126282" cy="5115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FSC-A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 rot="16200000">
              <a:off x="4448770" y="4289839"/>
              <a:ext cx="906390" cy="49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GFP</a:t>
              </a:r>
            </a:p>
          </p:txBody>
        </p:sp>
        <p:cxnSp>
          <p:nvCxnSpPr>
            <p:cNvPr id="76" name="Straight Arrow Connector 75"/>
            <p:cNvCxnSpPr/>
            <p:nvPr/>
          </p:nvCxnSpPr>
          <p:spPr>
            <a:xfrm flipH="1" flipV="1">
              <a:off x="5044296" y="3632202"/>
              <a:ext cx="1" cy="210042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 rot="16200000">
              <a:off x="1844631" y="4387442"/>
              <a:ext cx="1278246" cy="496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FLAG-PE</a:t>
              </a:r>
            </a:p>
          </p:txBody>
        </p:sp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10"/>
            <a:srcRect l="11882" b="10933"/>
            <a:stretch/>
          </p:blipFill>
          <p:spPr>
            <a:xfrm>
              <a:off x="5046387" y="3636034"/>
              <a:ext cx="2105799" cy="2096132"/>
            </a:xfrm>
            <a:prstGeom prst="rect">
              <a:avLst/>
            </a:prstGeom>
          </p:spPr>
        </p:pic>
        <p:pic>
          <p:nvPicPr>
            <p:cNvPr id="79" name="Picture 78"/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576799" y="3659565"/>
              <a:ext cx="2105060" cy="2096132"/>
            </a:xfrm>
            <a:prstGeom prst="rect">
              <a:avLst/>
            </a:prstGeom>
          </p:spPr>
        </p:pic>
      </p:grpSp>
      <p:sp>
        <p:nvSpPr>
          <p:cNvPr id="80" name="TextBox 79"/>
          <p:cNvSpPr txBox="1"/>
          <p:nvPr/>
        </p:nvSpPr>
        <p:spPr>
          <a:xfrm>
            <a:off x="1565792" y="3765208"/>
            <a:ext cx="71458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24h +dox</a:t>
            </a:r>
          </a:p>
        </p:txBody>
      </p:sp>
      <p:cxnSp>
        <p:nvCxnSpPr>
          <p:cNvPr id="81" name="Straight Connector 80"/>
          <p:cNvCxnSpPr/>
          <p:nvPr/>
        </p:nvCxnSpPr>
        <p:spPr>
          <a:xfrm>
            <a:off x="596997" y="3997679"/>
            <a:ext cx="25446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270448" y="5470981"/>
            <a:ext cx="297200" cy="3145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f</a:t>
            </a:r>
            <a:endParaRPr lang="en-GB" sz="1400" b="1" dirty="0"/>
          </a:p>
        </p:txBody>
      </p:sp>
      <p:grpSp>
        <p:nvGrpSpPr>
          <p:cNvPr id="13" name="Group 12"/>
          <p:cNvGrpSpPr/>
          <p:nvPr/>
        </p:nvGrpSpPr>
        <p:grpSpPr>
          <a:xfrm>
            <a:off x="3454826" y="3765208"/>
            <a:ext cx="2565716" cy="3769848"/>
            <a:chOff x="442506" y="5647924"/>
            <a:chExt cx="2565716" cy="3769848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9826F460-54CD-0347-8360-360DA436FB37}"/>
                </a:ext>
              </a:extLst>
            </p:cNvPr>
            <p:cNvGrpSpPr/>
            <p:nvPr/>
          </p:nvGrpSpPr>
          <p:grpSpPr>
            <a:xfrm>
              <a:off x="670760" y="5766431"/>
              <a:ext cx="2337462" cy="3433544"/>
              <a:chOff x="2374451" y="950878"/>
              <a:chExt cx="7055299" cy="4804628"/>
            </a:xfrm>
          </p:grpSpPr>
          <p:cxnSp>
            <p:nvCxnSpPr>
              <p:cNvPr id="84" name="Straight Arrow Connector 83">
                <a:extLst>
                  <a:ext uri="{FF2B5EF4-FFF2-40B4-BE49-F238E27FC236}">
                    <a16:creationId xmlns:a16="http://schemas.microsoft.com/office/drawing/2014/main" id="{D2FD5783-AB17-F443-9DD3-25C2EBB9B050}"/>
                  </a:ext>
                </a:extLst>
              </p:cNvPr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Arrow Connector 84">
                <a:extLst>
                  <a:ext uri="{FF2B5EF4-FFF2-40B4-BE49-F238E27FC236}">
                    <a16:creationId xmlns:a16="http://schemas.microsoft.com/office/drawing/2014/main" id="{FA41A0F5-DE36-284F-9D86-BD338CA78DAD}"/>
                  </a:ext>
                </a:extLst>
              </p:cNvPr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" name="TextBox 85"/>
            <p:cNvSpPr txBox="1"/>
            <p:nvPr/>
          </p:nvSpPr>
          <p:spPr>
            <a:xfrm>
              <a:off x="1616725" y="9163856"/>
              <a:ext cx="54570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FSC-A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 rot="16200000">
              <a:off x="145551" y="7347077"/>
              <a:ext cx="8478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Ki67-PECy7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933037" y="5652455"/>
              <a:ext cx="7986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24h +dox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071373" y="5647924"/>
              <a:ext cx="7035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96h +dox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38734" y="5818273"/>
              <a:ext cx="1171726" cy="1152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756980" y="5818273"/>
              <a:ext cx="1171726" cy="1152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43476" y="6938274"/>
              <a:ext cx="1171726" cy="1152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760998" y="6934154"/>
              <a:ext cx="1171726" cy="1152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38734" y="8050035"/>
              <a:ext cx="1171726" cy="11520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755450" y="8047975"/>
              <a:ext cx="1171726" cy="1152000"/>
            </a:xfrm>
            <a:prstGeom prst="rect">
              <a:avLst/>
            </a:prstGeom>
          </p:spPr>
        </p:pic>
      </p:grpSp>
      <p:sp>
        <p:nvSpPr>
          <p:cNvPr id="90" name="TextBox 89"/>
          <p:cNvSpPr txBox="1"/>
          <p:nvPr/>
        </p:nvSpPr>
        <p:spPr>
          <a:xfrm>
            <a:off x="3306780" y="3726284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g</a:t>
            </a:r>
            <a:endParaRPr lang="en-GB" sz="1400" b="1" dirty="0"/>
          </a:p>
        </p:txBody>
      </p:sp>
      <p:sp>
        <p:nvSpPr>
          <p:cNvPr id="91" name="TextBox 90"/>
          <p:cNvSpPr txBox="1"/>
          <p:nvPr/>
        </p:nvSpPr>
        <p:spPr>
          <a:xfrm rot="5400000">
            <a:off x="5766566" y="4375974"/>
            <a:ext cx="5997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 low</a:t>
            </a:r>
          </a:p>
        </p:txBody>
      </p:sp>
      <p:sp>
        <p:nvSpPr>
          <p:cNvPr id="92" name="TextBox 91"/>
          <p:cNvSpPr txBox="1"/>
          <p:nvPr/>
        </p:nvSpPr>
        <p:spPr>
          <a:xfrm rot="5400000">
            <a:off x="5875183" y="5517510"/>
            <a:ext cx="3825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-</a:t>
            </a:r>
          </a:p>
        </p:txBody>
      </p:sp>
      <p:sp>
        <p:nvSpPr>
          <p:cNvPr id="93" name="TextBox 92"/>
          <p:cNvSpPr txBox="1"/>
          <p:nvPr/>
        </p:nvSpPr>
        <p:spPr>
          <a:xfrm rot="5400000">
            <a:off x="5842823" y="6633390"/>
            <a:ext cx="4472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ox-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540431" y="7809100"/>
            <a:ext cx="4588852" cy="1166937"/>
            <a:chOff x="1733359" y="5539093"/>
            <a:chExt cx="2337462" cy="3433544"/>
          </a:xfrm>
        </p:grpSpPr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D2FD5783-AB17-F443-9DD3-25C2EBB9B050}"/>
                </a:ext>
              </a:extLst>
            </p:cNvPr>
            <p:cNvCxnSpPr/>
            <p:nvPr/>
          </p:nvCxnSpPr>
          <p:spPr>
            <a:xfrm>
              <a:off x="1733359" y="8972637"/>
              <a:ext cx="23374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FA41A0F5-DE36-284F-9D86-BD338CA78DAD}"/>
                </a:ext>
              </a:extLst>
            </p:cNvPr>
            <p:cNvCxnSpPr/>
            <p:nvPr/>
          </p:nvCxnSpPr>
          <p:spPr>
            <a:xfrm flipV="1">
              <a:off x="1734722" y="5539093"/>
              <a:ext cx="0" cy="343354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TextBox 95"/>
          <p:cNvSpPr txBox="1"/>
          <p:nvPr/>
        </p:nvSpPr>
        <p:spPr>
          <a:xfrm>
            <a:off x="2530170" y="8951201"/>
            <a:ext cx="6598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Hoechst</a:t>
            </a:r>
          </a:p>
        </p:txBody>
      </p:sp>
      <p:sp>
        <p:nvSpPr>
          <p:cNvPr id="97" name="TextBox 96"/>
          <p:cNvSpPr txBox="1"/>
          <p:nvPr/>
        </p:nvSpPr>
        <p:spPr>
          <a:xfrm rot="16200000">
            <a:off x="198688" y="8258143"/>
            <a:ext cx="48496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err="1"/>
              <a:t>EdU</a:t>
            </a:r>
            <a:endParaRPr lang="en-GB" sz="105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889440" y="7618787"/>
            <a:ext cx="7765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 high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2006266" y="7618787"/>
            <a:ext cx="7525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 low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3236442" y="7619652"/>
            <a:ext cx="5221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-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4367587" y="7618787"/>
            <a:ext cx="5135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ox-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33962" y="7464899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h</a:t>
            </a:r>
            <a:endParaRPr lang="en-GB" sz="1400" b="1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03149" y="7830434"/>
            <a:ext cx="1171726" cy="1152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624869" y="7830434"/>
            <a:ext cx="1171726" cy="11520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747232" y="7832271"/>
            <a:ext cx="1171726" cy="11520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878951" y="7829513"/>
            <a:ext cx="1171726" cy="115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3131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5562" y="440936"/>
            <a:ext cx="6046749" cy="36009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Supplementary Figure 1. A model for generating endothelial cells with inducible TC expression.</a:t>
            </a:r>
          </a:p>
          <a:p>
            <a:pPr algn="just"/>
            <a:r>
              <a:rPr lang="en-GB" sz="1200" b="1" dirty="0" smtClean="0"/>
              <a:t>a </a:t>
            </a:r>
            <a:r>
              <a:rPr lang="en-GB" sz="1200" dirty="0" smtClean="0"/>
              <a:t>Differentiation </a:t>
            </a:r>
            <a:r>
              <a:rPr lang="en-GB" sz="1200" dirty="0"/>
              <a:t>timeline for the production of endothelial cells from mESCs, by sorting a progenitor population from EBs.</a:t>
            </a:r>
          </a:p>
          <a:p>
            <a:pPr algn="just"/>
            <a:r>
              <a:rPr lang="en-GB" sz="1200" b="1" dirty="0"/>
              <a:t>b</a:t>
            </a:r>
            <a:r>
              <a:rPr lang="en-GB" sz="1200" b="1" dirty="0" smtClean="0"/>
              <a:t> </a:t>
            </a:r>
            <a:r>
              <a:rPr lang="en-GB" sz="1200" dirty="0"/>
              <a:t>Representative flow cytometry plot showing the TIE2+ FLK1+ population sorted from day 5 EBs for endothelial cell differentiation. </a:t>
            </a:r>
          </a:p>
          <a:p>
            <a:pPr lvl="0" algn="just" defTabSz="914400">
              <a:defRPr/>
            </a:pPr>
            <a:r>
              <a:rPr lang="en-GB" sz="1200" b="1" dirty="0"/>
              <a:t>c</a:t>
            </a:r>
            <a:r>
              <a:rPr lang="en-GB" sz="1200" b="1" dirty="0" smtClean="0"/>
              <a:t> </a:t>
            </a:r>
            <a:r>
              <a:rPr lang="en-GB" sz="1200" dirty="0"/>
              <a:t>Representative image showing tube-like formation ability of endothelial cells in Matrigel plug. Scale bar=100</a:t>
            </a:r>
            <a:r>
              <a:rPr lang="en-GB" sz="1200" dirty="0">
                <a:sym typeface="Symbol" panose="05050102010706020507" pitchFamily="18" charset="2"/>
              </a:rPr>
              <a:t></a:t>
            </a:r>
            <a:r>
              <a:rPr lang="en-GB" sz="1200" dirty="0"/>
              <a:t>m.</a:t>
            </a:r>
            <a:endParaRPr lang="en-GB" sz="1200" b="1" dirty="0"/>
          </a:p>
          <a:p>
            <a:pPr lvl="0" algn="just" defTabSz="914400">
              <a:defRPr/>
            </a:pPr>
            <a:r>
              <a:rPr lang="en-GB" sz="1200" b="1" dirty="0"/>
              <a:t>d</a:t>
            </a:r>
            <a:r>
              <a:rPr lang="en-GB" sz="1200" b="1" dirty="0" smtClean="0"/>
              <a:t> </a:t>
            </a:r>
            <a:r>
              <a:rPr lang="en-GB" sz="1200" dirty="0"/>
              <a:t>Representative flow cytometry plots showing the expression of four endothelial cell markers (FLK1, TIE2, CD31, VE-Cadherin) in endothelial cells 7 days after sorting.</a:t>
            </a:r>
          </a:p>
          <a:p>
            <a:pPr lvl="0" algn="just" defTabSz="914400">
              <a:defRPr/>
            </a:pPr>
            <a:r>
              <a:rPr lang="en-GB" sz="1200" b="1" dirty="0"/>
              <a:t>e</a:t>
            </a:r>
            <a:r>
              <a:rPr lang="en-GB" sz="1200" b="1" dirty="0" smtClean="0"/>
              <a:t> </a:t>
            </a:r>
            <a:r>
              <a:rPr lang="en-GB" sz="1200" dirty="0"/>
              <a:t>Representative flow cytometry plots showing FLAG and GFP expression against FSC-A, both of which are markers of TC.</a:t>
            </a:r>
          </a:p>
          <a:p>
            <a:pPr algn="just"/>
            <a:r>
              <a:rPr lang="en-GB" sz="1200" b="1" dirty="0"/>
              <a:t>f</a:t>
            </a:r>
            <a:r>
              <a:rPr lang="en-GB" sz="1200" b="1" dirty="0" smtClean="0"/>
              <a:t> </a:t>
            </a:r>
            <a:r>
              <a:rPr lang="en-GB" sz="1200" dirty="0"/>
              <a:t>Positive correlation between TC expression, measured using the FLAG epitope, and GFP expression, which is expressed via an IRES upon dox induction for tracking induced cells. </a:t>
            </a:r>
          </a:p>
          <a:p>
            <a:pPr lvl="0" algn="just" defTabSz="914400">
              <a:defRPr/>
            </a:pPr>
            <a:r>
              <a:rPr lang="en-GB" sz="1200" b="1" dirty="0"/>
              <a:t>g</a:t>
            </a:r>
            <a:r>
              <a:rPr lang="en-GB" sz="1200" b="1" dirty="0" smtClean="0"/>
              <a:t> </a:t>
            </a:r>
            <a:r>
              <a:rPr lang="en-GB" sz="1200" dirty="0"/>
              <a:t>Representative flow cytometry plots showing the percentage of Ki67+ endothelial cells within TC low, neg, and uninduced populations, at 24h and 96h after dox induction. </a:t>
            </a:r>
          </a:p>
          <a:p>
            <a:pPr lvl="0" algn="just" defTabSz="914400">
              <a:defRPr/>
            </a:pPr>
            <a:r>
              <a:rPr lang="en-GB" sz="1200" b="1" dirty="0"/>
              <a:t>h</a:t>
            </a:r>
            <a:r>
              <a:rPr lang="en-GB" sz="1200" b="1" dirty="0" smtClean="0"/>
              <a:t> </a:t>
            </a:r>
            <a:r>
              <a:rPr lang="en-GB" sz="1200" dirty="0"/>
              <a:t>Representative flow cytometry plots showing </a:t>
            </a:r>
            <a:r>
              <a:rPr lang="en-GB" sz="1200" dirty="0" smtClean="0"/>
              <a:t>EdU </a:t>
            </a:r>
            <a:r>
              <a:rPr lang="en-GB" sz="1200" dirty="0"/>
              <a:t>incorporation against Hoechst staining in TC high, TC low, TC- and uninduced endothelial cell populations when not subject to cell cycle synchronisation. 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975528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501" y="2011572"/>
            <a:ext cx="900000" cy="9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705" y="1097282"/>
            <a:ext cx="900000" cy="90000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899" y="2011572"/>
            <a:ext cx="900000" cy="9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103" y="1097282"/>
            <a:ext cx="900000" cy="9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501" y="1097282"/>
            <a:ext cx="900000" cy="9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705" y="2011572"/>
            <a:ext cx="900000" cy="900000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899" y="1097282"/>
            <a:ext cx="900000" cy="900000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103" y="2014673"/>
            <a:ext cx="900000" cy="90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3211604" y="1030215"/>
            <a:ext cx="1161214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50" dirty="0">
                <a:solidFill>
                  <a:srgbClr val="0066FF"/>
                </a:solidFill>
              </a:rPr>
              <a:t>DAPI</a:t>
            </a:r>
            <a:r>
              <a:rPr lang="en-GB" sz="950" dirty="0"/>
              <a:t> </a:t>
            </a:r>
            <a:r>
              <a:rPr lang="el-GR" sz="950" dirty="0">
                <a:solidFill>
                  <a:srgbClr val="FFFF00"/>
                </a:solidFill>
              </a:rPr>
              <a:t>γ</a:t>
            </a:r>
            <a:r>
              <a:rPr lang="en-GB" sz="950" dirty="0">
                <a:solidFill>
                  <a:srgbClr val="FFFF00"/>
                </a:solidFill>
              </a:rPr>
              <a:t>H2AX </a:t>
            </a:r>
            <a:r>
              <a:rPr lang="en-GB" sz="950" dirty="0">
                <a:solidFill>
                  <a:srgbClr val="FF3399"/>
                </a:solidFill>
              </a:rPr>
              <a:t>FLA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71576" y="1030215"/>
            <a:ext cx="488887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50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010361" y="1030215"/>
            <a:ext cx="617144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50" dirty="0">
                <a:solidFill>
                  <a:schemeClr val="bg1"/>
                </a:solidFill>
              </a:rPr>
              <a:t>γ</a:t>
            </a:r>
            <a:r>
              <a:rPr lang="en-GB" sz="950" dirty="0">
                <a:solidFill>
                  <a:schemeClr val="bg1"/>
                </a:solidFill>
              </a:rPr>
              <a:t>H2AX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007389" y="1030215"/>
            <a:ext cx="465137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50" dirty="0">
                <a:solidFill>
                  <a:schemeClr val="bg1"/>
                </a:solidFill>
              </a:rPr>
              <a:t>FLAG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625981" y="1044642"/>
            <a:ext cx="3654000" cy="1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129371" y="828939"/>
            <a:ext cx="656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dox 4h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99127" y="722438"/>
            <a:ext cx="247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551620" y="741812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211843" y="2315683"/>
            <a:ext cx="67589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 S51A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355429" y="1405896"/>
            <a:ext cx="3887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T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2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4624703" y="828939"/>
          <a:ext cx="2001378" cy="21980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0" name="Prism 8" r:id="rId12" imgW="2649879" imgH="2910405" progId="Prism8.Document">
                  <p:embed/>
                </p:oleObj>
              </mc:Choice>
              <mc:Fallback>
                <p:oleObj name="Prism 8" r:id="rId12" imgW="2649879" imgH="2910405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624703" y="828939"/>
                        <a:ext cx="2001378" cy="21980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/>
          <p:cNvSpPr/>
          <p:nvPr/>
        </p:nvSpPr>
        <p:spPr>
          <a:xfrm>
            <a:off x="205811" y="3579659"/>
            <a:ext cx="6324584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GB" sz="1200" b="1" dirty="0"/>
              <a:t>Supplementary Figure 2. TC causes endothelial cells to accumulate DNA double strand breaks</a:t>
            </a:r>
            <a:r>
              <a:rPr lang="en-GB" sz="1200" dirty="0"/>
              <a:t> </a:t>
            </a:r>
            <a:r>
              <a:rPr lang="en-GB" sz="1200" b="1" dirty="0"/>
              <a:t>immediately upon its expression</a:t>
            </a:r>
          </a:p>
          <a:p>
            <a:pPr lvl="0" algn="just" defTabSz="914400">
              <a:defRPr/>
            </a:pPr>
            <a:r>
              <a:rPr lang="en-GB" sz="1200" b="1" dirty="0"/>
              <a:t>a</a:t>
            </a:r>
            <a:r>
              <a:rPr lang="en-GB" sz="1200" b="1" dirty="0" smtClean="0"/>
              <a:t> </a:t>
            </a:r>
            <a:r>
              <a:rPr lang="en-GB" sz="1200" dirty="0"/>
              <a:t>Representative images showing endothelial cells treated with dox for 4h to induce TC expression. Cells treated with 30</a:t>
            </a:r>
            <a:r>
              <a:rPr lang="el-GR" sz="1200" dirty="0"/>
              <a:t>μ</a:t>
            </a:r>
            <a:r>
              <a:rPr lang="en-GB" sz="1200" dirty="0"/>
              <a:t>M H</a:t>
            </a:r>
            <a:r>
              <a:rPr lang="en-GB" sz="1200" baseline="-25000" dirty="0"/>
              <a:t>2</a:t>
            </a:r>
            <a:r>
              <a:rPr lang="en-GB" sz="1200" dirty="0"/>
              <a:t>O</a:t>
            </a:r>
            <a:r>
              <a:rPr lang="en-GB" sz="1200" baseline="-25000" dirty="0"/>
              <a:t>2 </a:t>
            </a:r>
            <a:r>
              <a:rPr lang="en-GB" sz="1200" dirty="0"/>
              <a:t>for 4h were used as a positive control.</a:t>
            </a:r>
            <a:r>
              <a:rPr lang="en-GB" sz="1200" baseline="-25000" dirty="0"/>
              <a:t> </a:t>
            </a:r>
            <a:r>
              <a:rPr lang="en-GB" sz="1200" dirty="0"/>
              <a:t>Cells were stained with DAPI (nuclei; blue), FLAG antibody (TC; magenta), and </a:t>
            </a:r>
            <a:r>
              <a:rPr lang="el-GR" sz="1200" dirty="0"/>
              <a:t>γ</a:t>
            </a:r>
            <a:r>
              <a:rPr lang="en-GB" sz="1200" dirty="0"/>
              <a:t>H2AX antibody (phospho-H2AX; yellow). All imaging was performed on a Zeiss fluorescence widefield microscope using a 63x oil immersion objective. Scale bars=20</a:t>
            </a:r>
            <a:r>
              <a:rPr lang="en-GB" sz="1200" dirty="0">
                <a:sym typeface="Symbol" panose="05050102010706020507" pitchFamily="18" charset="2"/>
              </a:rPr>
              <a:t></a:t>
            </a:r>
            <a:r>
              <a:rPr lang="en-GB" sz="1200" dirty="0"/>
              <a:t>m. </a:t>
            </a:r>
          </a:p>
          <a:p>
            <a:pPr algn="just" defTabSz="914400">
              <a:defRPr/>
            </a:pPr>
            <a:r>
              <a:rPr lang="en-GB" sz="1200" b="1" dirty="0"/>
              <a:t>b</a:t>
            </a:r>
            <a:r>
              <a:rPr lang="en-GB" sz="1200" b="1" dirty="0" smtClean="0"/>
              <a:t> </a:t>
            </a:r>
            <a:r>
              <a:rPr lang="en-GB" sz="1200" dirty="0"/>
              <a:t>The frequency of endothelial cells positive for </a:t>
            </a:r>
            <a:r>
              <a:rPr lang="el-GR" sz="1200" dirty="0"/>
              <a:t>γ</a:t>
            </a:r>
            <a:r>
              <a:rPr lang="en-GB" sz="1200" dirty="0"/>
              <a:t>H2AX foci from the imaging experiments as presented in </a:t>
            </a:r>
            <a:r>
              <a:rPr lang="en-GB" sz="1200" b="1" dirty="0"/>
              <a:t>a</a:t>
            </a:r>
            <a:r>
              <a:rPr lang="en-GB" sz="1200" b="1" dirty="0" smtClean="0"/>
              <a:t>. </a:t>
            </a:r>
            <a:r>
              <a:rPr lang="en-GB" sz="1200" dirty="0"/>
              <a:t>Cells with &gt;10 foci were considered positive. A minimum of 150 cells per condition were analysed, n=3. Significance was calculated by one-way ANOVA and </a:t>
            </a:r>
            <a:r>
              <a:rPr lang="en-GB" sz="1200" dirty="0" err="1"/>
              <a:t>Dunnett’s</a:t>
            </a:r>
            <a:r>
              <a:rPr lang="en-GB" sz="1200" dirty="0"/>
              <a:t> multiple comparisons </a:t>
            </a:r>
            <a:r>
              <a:rPr lang="en-GB" sz="1200" dirty="0" smtClean="0"/>
              <a:t>test. All error </a:t>
            </a:r>
            <a:r>
              <a:rPr lang="en-GB" sz="1200" dirty="0"/>
              <a:t>bars show SEM, and *p&lt;0.05, **p&lt;0.01, ***p&lt;0.001, ****p&lt;0.0001.</a:t>
            </a:r>
          </a:p>
          <a:p>
            <a:pPr lvl="0" algn="just" defTabSz="914400">
              <a:defRPr/>
            </a:pP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8265819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01290" y="794461"/>
            <a:ext cx="2881449" cy="1692144"/>
            <a:chOff x="122538" y="432628"/>
            <a:chExt cx="4592808" cy="2587497"/>
          </a:xfrm>
        </p:grpSpPr>
        <p:pic>
          <p:nvPicPr>
            <p:cNvPr id="14" name="Picture 13" descr="Chart, histogram&#10;&#10;Description automatically generated">
              <a:extLst>
                <a:ext uri="{FF2B5EF4-FFF2-40B4-BE49-F238E27FC236}">
                  <a16:creationId xmlns:a16="http://schemas.microsoft.com/office/drawing/2014/main" id="{3579B981-E358-714A-BE29-452A16B9A8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758" b="5858"/>
            <a:stretch/>
          </p:blipFill>
          <p:spPr>
            <a:xfrm>
              <a:off x="516184" y="745317"/>
              <a:ext cx="2123515" cy="1888855"/>
            </a:xfrm>
            <a:prstGeom prst="rect">
              <a:avLst/>
            </a:prstGeom>
          </p:spPr>
        </p:pic>
        <p:pic>
          <p:nvPicPr>
            <p:cNvPr id="15" name="Picture 14" descr="Chart, histogram&#10;&#10;Description automatically generated">
              <a:extLst>
                <a:ext uri="{FF2B5EF4-FFF2-40B4-BE49-F238E27FC236}">
                  <a16:creationId xmlns:a16="http://schemas.microsoft.com/office/drawing/2014/main" id="{D3A03A9B-B6BF-834F-8113-084CAD54C3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281" b="5082"/>
            <a:stretch/>
          </p:blipFill>
          <p:spPr>
            <a:xfrm>
              <a:off x="2591831" y="735231"/>
              <a:ext cx="2123515" cy="1888854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826F460-54CD-0347-8360-360DA436FB37}"/>
                </a:ext>
              </a:extLst>
            </p:cNvPr>
            <p:cNvGrpSpPr/>
            <p:nvPr/>
          </p:nvGrpSpPr>
          <p:grpSpPr>
            <a:xfrm>
              <a:off x="500325" y="625574"/>
              <a:ext cx="4215021" cy="2021677"/>
              <a:chOff x="2374451" y="950878"/>
              <a:chExt cx="7055299" cy="4804628"/>
            </a:xfrm>
          </p:grpSpPr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D2FD5783-AB17-F443-9DD3-25C2EBB9B050}"/>
                  </a:ext>
                </a:extLst>
              </p:cNvPr>
              <p:cNvCxnSpPr/>
              <p:nvPr/>
            </p:nvCxnSpPr>
            <p:spPr>
              <a:xfrm>
                <a:off x="2374451" y="5755506"/>
                <a:ext cx="705529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FA41A0F5-DE36-284F-9D86-BD338CA78DAD}"/>
                  </a:ext>
                </a:extLst>
              </p:cNvPr>
              <p:cNvCxnSpPr/>
              <p:nvPr/>
            </p:nvCxnSpPr>
            <p:spPr>
              <a:xfrm flipV="1">
                <a:off x="2378566" y="950878"/>
                <a:ext cx="0" cy="4804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1D6299D-90DA-B443-B1E2-DB1F8316083F}"/>
                </a:ext>
              </a:extLst>
            </p:cNvPr>
            <p:cNvSpPr txBox="1"/>
            <p:nvPr/>
          </p:nvSpPr>
          <p:spPr>
            <a:xfrm>
              <a:off x="2314796" y="2631856"/>
              <a:ext cx="682443" cy="3882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GFP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03470" y="432628"/>
              <a:ext cx="838472" cy="3882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-dox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51738" y="432628"/>
              <a:ext cx="1192219" cy="3882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+dox 24h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1D6299D-90DA-B443-B1E2-DB1F8316083F}"/>
                </a:ext>
              </a:extLst>
            </p:cNvPr>
            <p:cNvSpPr txBox="1"/>
            <p:nvPr/>
          </p:nvSpPr>
          <p:spPr>
            <a:xfrm rot="16200000">
              <a:off x="-145680" y="1372468"/>
              <a:ext cx="941159" cy="404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Count</a:t>
              </a: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207776" y="734087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c</a:t>
            </a:r>
            <a:endParaRPr lang="en-GB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885771" y="734086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d</a:t>
            </a:r>
            <a:endParaRPr lang="en-GB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02341" y="734088"/>
            <a:ext cx="265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202341" y="2495159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43788" y="2614013"/>
          <a:ext cx="2022458" cy="19940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4" name="Prism 8" r:id="rId6" imgW="2940868" imgH="2899960" progId="Prism8.Document">
                  <p:embed/>
                </p:oleObj>
              </mc:Choice>
              <mc:Fallback>
                <p:oleObj name="Prism 8" r:id="rId6" imgW="2940868" imgH="2899960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3788" y="2614013"/>
                        <a:ext cx="2022458" cy="19940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93" r="57441"/>
          <a:stretch/>
        </p:blipFill>
        <p:spPr>
          <a:xfrm>
            <a:off x="3494664" y="1123950"/>
            <a:ext cx="952728" cy="5181783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6" t="-810" r="3687" b="95434"/>
          <a:stretch/>
        </p:blipFill>
        <p:spPr>
          <a:xfrm>
            <a:off x="3436956" y="914461"/>
            <a:ext cx="1385336" cy="20948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6" r="55584"/>
          <a:stretch/>
        </p:blipFill>
        <p:spPr>
          <a:xfrm>
            <a:off x="5181863" y="1123950"/>
            <a:ext cx="954000" cy="736262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6" t="-810" r="3687" b="95434"/>
          <a:stretch/>
        </p:blipFill>
        <p:spPr>
          <a:xfrm>
            <a:off x="5113895" y="914461"/>
            <a:ext cx="1385336" cy="209489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168153" y="6803988"/>
            <a:ext cx="4890074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Supplementary Figure 3. RNA-seq analysis reveals enrichment for EHE and TAZ/YAP targets in TC expressing endothelial cells.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a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 smtClean="0">
                <a:solidFill>
                  <a:prstClr val="black"/>
                </a:solidFill>
              </a:rPr>
              <a:t>Representative </a:t>
            </a:r>
            <a:r>
              <a:rPr lang="en-GB" sz="1200" dirty="0">
                <a:solidFill>
                  <a:prstClr val="black"/>
                </a:solidFill>
              </a:rPr>
              <a:t>flow cytometry histograms showing the populations sorted from day 11 endothelial cells for RNA sequencing samples, based on GFP expression as a marker for TC expression. Dox was added or not to cells 24 hours prior, and then sorted into GFP- (purple), GFP low (light green), and GFP high (dark green) samples.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b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TC RNA expression in each of the four samples sorted based on GFP expression in </a:t>
            </a:r>
            <a:r>
              <a:rPr lang="en-GB" sz="1200" b="1" dirty="0" smtClean="0">
                <a:solidFill>
                  <a:prstClr val="black"/>
                </a:solidFill>
              </a:rPr>
              <a:t>a.</a:t>
            </a:r>
            <a:endParaRPr lang="en-GB" sz="1200" b="1" dirty="0">
              <a:solidFill>
                <a:prstClr val="black"/>
              </a:solidFill>
            </a:endParaRP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c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Heatmap showing log2 fold change in RNA expression of Cordenonsi YAP conserved signature gene set when comparing TC high, TC low and TC- endothelial cell populations to uninduced controls. 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d</a:t>
            </a:r>
            <a:r>
              <a:rPr lang="en-GB" sz="1200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Heatmap showing log2 fold change in RNA expression of Seavey Epithelioid Haemangioendothelioma gene set when comparing TC high, TC low and TC- endothelial cell populations to uninduced controls. </a:t>
            </a:r>
          </a:p>
        </p:txBody>
      </p:sp>
    </p:spTree>
    <p:extLst>
      <p:ext uri="{BB962C8B-B14F-4D97-AF65-F5344CB8AC3E}">
        <p14:creationId xmlns:p14="http://schemas.microsoft.com/office/powerpoint/2010/main" val="4188107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64555" y="2033876"/>
            <a:ext cx="1044000" cy="102442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42469" y="1905124"/>
            <a:ext cx="73448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FLAG-P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309692" y="3058556"/>
            <a:ext cx="5529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FSC-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59954" y="884251"/>
            <a:ext cx="6126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94923" y="873541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08990" y="868686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65983" y="664234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685314" y="664234"/>
            <a:ext cx="2357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58714" y="2037150"/>
            <a:ext cx="1043568" cy="1026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67143" y="2032148"/>
            <a:ext cx="1043568" cy="1026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3662" y="2033876"/>
            <a:ext cx="1043569" cy="1026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692081" y="868816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2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826F460-54CD-0347-8360-360DA436FB37}"/>
              </a:ext>
            </a:extLst>
          </p:cNvPr>
          <p:cNvGrpSpPr/>
          <p:nvPr/>
        </p:nvGrpSpPr>
        <p:grpSpPr>
          <a:xfrm>
            <a:off x="475837" y="1057681"/>
            <a:ext cx="4198784" cy="2000467"/>
            <a:chOff x="2374451" y="950878"/>
            <a:chExt cx="7055299" cy="4804628"/>
          </a:xfrm>
        </p:grpSpPr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D2FD5783-AB17-F443-9DD3-25C2EBB9B050}"/>
                </a:ext>
              </a:extLst>
            </p:cNvPr>
            <p:cNvCxnSpPr/>
            <p:nvPr/>
          </p:nvCxnSpPr>
          <p:spPr>
            <a:xfrm>
              <a:off x="2374451" y="5755506"/>
              <a:ext cx="705529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A41A0F5-DE36-284F-9D86-BD338CA78DAD}"/>
                </a:ext>
              </a:extLst>
            </p:cNvPr>
            <p:cNvCxnSpPr/>
            <p:nvPr/>
          </p:nvCxnSpPr>
          <p:spPr>
            <a:xfrm flipV="1">
              <a:off x="2378566" y="950878"/>
              <a:ext cx="0" cy="48046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7" name="Picture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0411" y="1052828"/>
            <a:ext cx="1043568" cy="1026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59837" y="1057787"/>
            <a:ext cx="1043568" cy="10260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52748" y="1051595"/>
            <a:ext cx="1043568" cy="1026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62049" y="1057132"/>
            <a:ext cx="1043568" cy="10260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 rot="5400000">
            <a:off x="4312109" y="2425551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14 </a:t>
            </a:r>
          </a:p>
        </p:txBody>
      </p:sp>
      <p:sp>
        <p:nvSpPr>
          <p:cNvPr id="22" name="TextBox 21"/>
          <p:cNvSpPr txBox="1"/>
          <p:nvPr/>
        </p:nvSpPr>
        <p:spPr>
          <a:xfrm rot="5400000">
            <a:off x="4312109" y="1479104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7</a:t>
            </a: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4792140" y="780270"/>
          <a:ext cx="2065860" cy="19467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48" name="Prism 8" r:id="rId12" imgW="2863079" imgH="2698634" progId="Prism8.Document">
                  <p:embed/>
                </p:oleObj>
              </mc:Choice>
              <mc:Fallback>
                <p:oleObj name="Prism 8" r:id="rId12" imgW="2863079" imgH="2698634" progId="Prism8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792140" y="780270"/>
                        <a:ext cx="2065860" cy="19467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4</a:t>
            </a:r>
          </a:p>
        </p:txBody>
      </p:sp>
      <p:sp>
        <p:nvSpPr>
          <p:cNvPr id="25" name="Rectangle 24"/>
          <p:cNvSpPr/>
          <p:nvPr/>
        </p:nvSpPr>
        <p:spPr>
          <a:xfrm>
            <a:off x="110993" y="3505868"/>
            <a:ext cx="670211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Supplementary Figure 4. </a:t>
            </a:r>
            <a:r>
              <a:rPr lang="en-GB" sz="1200" b="1" i="1" dirty="0">
                <a:solidFill>
                  <a:prstClr val="black"/>
                </a:solidFill>
              </a:rPr>
              <a:t>Cdkn2a </a:t>
            </a:r>
            <a:r>
              <a:rPr lang="en-GB" sz="1200" b="1" dirty="0">
                <a:solidFill>
                  <a:prstClr val="black"/>
                </a:solidFill>
              </a:rPr>
              <a:t>knockdown endothelial cells allows increased TC expression.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a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Representative flow cytometry plots showing TC expression against FSC-A at day 14 after </a:t>
            </a:r>
            <a:r>
              <a:rPr lang="en-GB" sz="1200" i="1" dirty="0">
                <a:solidFill>
                  <a:prstClr val="black"/>
                </a:solidFill>
              </a:rPr>
              <a:t>Cdkn2a </a:t>
            </a:r>
            <a:r>
              <a:rPr lang="en-GB" sz="1200" dirty="0">
                <a:solidFill>
                  <a:prstClr val="black"/>
                </a:solidFill>
              </a:rPr>
              <a:t>knockout or not. 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b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Fold change of TC high population between days 7 and 14 after addition of dox in comparison to uninduced, </a:t>
            </a:r>
            <a:r>
              <a:rPr lang="en-GB" sz="1200" i="1" dirty="0">
                <a:solidFill>
                  <a:prstClr val="black"/>
                </a:solidFill>
              </a:rPr>
              <a:t>Cdkn2a </a:t>
            </a:r>
            <a:r>
              <a:rPr lang="en-GB" sz="1200" dirty="0">
                <a:solidFill>
                  <a:prstClr val="black"/>
                </a:solidFill>
              </a:rPr>
              <a:t>knockout endothelial cells, n=4. Statistical significance was calculated with a two-way ANOVA and Sidak’s multiple comparisons test. </a:t>
            </a:r>
            <a:r>
              <a:rPr lang="en-GB" sz="1200" dirty="0" smtClean="0">
                <a:solidFill>
                  <a:prstClr val="black"/>
                </a:solidFill>
              </a:rPr>
              <a:t>All </a:t>
            </a:r>
            <a:r>
              <a:rPr lang="en-GB" sz="1200" dirty="0"/>
              <a:t>e</a:t>
            </a:r>
            <a:r>
              <a:rPr lang="en-GB" sz="1200" dirty="0" smtClean="0"/>
              <a:t>rror </a:t>
            </a:r>
            <a:r>
              <a:rPr lang="en-GB" sz="1200" dirty="0"/>
              <a:t>bars show SEM, and *p&lt;0.05, **p&lt;0.01, ***p&lt;0.001, ****p&lt;0.0001.</a:t>
            </a:r>
            <a:endParaRPr lang="en-GB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55621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</a:t>
            </a:r>
            <a:r>
              <a:rPr lang="en-GB" sz="2400" b="1" dirty="0" smtClean="0"/>
              <a:t>5</a:t>
            </a:r>
            <a:endParaRPr lang="en-GB" sz="24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114020" y="544601"/>
            <a:ext cx="265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297306" y="497982"/>
            <a:ext cx="296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14020" y="2423331"/>
            <a:ext cx="271057" cy="310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c</a:t>
            </a:r>
            <a:endParaRPr lang="en-GB" sz="1400" b="1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50978" y="577230"/>
          <a:ext cx="2686837" cy="190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14" name="Prism 8" r:id="rId4" imgW="3814557" imgH="2698634" progId="Prism8.Document">
                  <p:embed/>
                </p:oleObj>
              </mc:Choice>
              <mc:Fallback>
                <p:oleObj name="Prism 8" r:id="rId4" imgW="3814557" imgH="2698634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0978" y="577230"/>
                        <a:ext cx="2686837" cy="190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/>
          </p:nvPr>
        </p:nvGraphicFramePr>
        <p:xfrm>
          <a:off x="3510877" y="583262"/>
          <a:ext cx="2684328" cy="1899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15" name="Prism 8" r:id="rId6" imgW="3814557" imgH="2698634" progId="Prism8.Document">
                  <p:embed/>
                </p:oleObj>
              </mc:Choice>
              <mc:Fallback>
                <p:oleObj name="Prism 8" r:id="rId6" imgW="3814557" imgH="2698634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10877" y="583262"/>
                        <a:ext cx="2684328" cy="1899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/>
          <p:cNvSpPr txBox="1"/>
          <p:nvPr/>
        </p:nvSpPr>
        <p:spPr>
          <a:xfrm rot="16200000">
            <a:off x="-112883" y="3529428"/>
            <a:ext cx="8885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Ki67-PECy7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9826F460-54CD-0347-8360-360DA436FB37}"/>
              </a:ext>
            </a:extLst>
          </p:cNvPr>
          <p:cNvGrpSpPr/>
          <p:nvPr/>
        </p:nvGrpSpPr>
        <p:grpSpPr>
          <a:xfrm>
            <a:off x="423874" y="2672397"/>
            <a:ext cx="4126959" cy="2000467"/>
            <a:chOff x="2374451" y="950878"/>
            <a:chExt cx="7055299" cy="4804628"/>
          </a:xfrm>
        </p:grpSpPr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D2FD5783-AB17-F443-9DD3-25C2EBB9B050}"/>
                </a:ext>
              </a:extLst>
            </p:cNvPr>
            <p:cNvCxnSpPr/>
            <p:nvPr/>
          </p:nvCxnSpPr>
          <p:spPr>
            <a:xfrm>
              <a:off x="2374451" y="5755506"/>
              <a:ext cx="705529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FA41A0F5-DE36-284F-9D86-BD338CA78DAD}"/>
                </a:ext>
              </a:extLst>
            </p:cNvPr>
            <p:cNvCxnSpPr/>
            <p:nvPr/>
          </p:nvCxnSpPr>
          <p:spPr>
            <a:xfrm flipV="1">
              <a:off x="2378566" y="950878"/>
              <a:ext cx="0" cy="48046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2255955" y="4671593"/>
            <a:ext cx="5529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FSC-A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1039" y="2671126"/>
            <a:ext cx="1043568" cy="10260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5553" y="3646864"/>
            <a:ext cx="1043568" cy="10260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06931" y="3646864"/>
            <a:ext cx="1043568" cy="102600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12417" y="2671126"/>
            <a:ext cx="1043568" cy="1026000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15180" y="3646864"/>
            <a:ext cx="1043568" cy="102600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15914" y="2672397"/>
            <a:ext cx="1043568" cy="102600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669419" y="2499329"/>
            <a:ext cx="6126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Control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653028" y="2488619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655784" y="2498689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3</a:t>
            </a:r>
          </a:p>
        </p:txBody>
      </p:sp>
      <p:sp>
        <p:nvSpPr>
          <p:cNvPr id="55" name="TextBox 54"/>
          <p:cNvSpPr txBox="1"/>
          <p:nvPr/>
        </p:nvSpPr>
        <p:spPr>
          <a:xfrm rot="5400000">
            <a:off x="4250903" y="4054190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14 </a:t>
            </a:r>
          </a:p>
        </p:txBody>
      </p:sp>
      <p:sp>
        <p:nvSpPr>
          <p:cNvPr id="56" name="TextBox 55"/>
          <p:cNvSpPr txBox="1"/>
          <p:nvPr/>
        </p:nvSpPr>
        <p:spPr>
          <a:xfrm rot="5400000">
            <a:off x="4250903" y="3107743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7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676293" y="2423330"/>
            <a:ext cx="271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d</a:t>
            </a:r>
            <a:endParaRPr lang="en-GB" sz="1400" b="1" dirty="0"/>
          </a:p>
        </p:txBody>
      </p:sp>
      <p:pic>
        <p:nvPicPr>
          <p:cNvPr id="61" name="Picture 6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417384" y="3646864"/>
            <a:ext cx="1043568" cy="1026000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17384" y="2671126"/>
            <a:ext cx="1043568" cy="1026000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2654406" y="2499329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2</a:t>
            </a:r>
          </a:p>
        </p:txBody>
      </p:sp>
      <p:graphicFrame>
        <p:nvGraphicFramePr>
          <p:cNvPr id="76" name="Object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5638712"/>
              </p:ext>
            </p:extLst>
          </p:nvPr>
        </p:nvGraphicFramePr>
        <p:xfrm>
          <a:off x="4747038" y="2499721"/>
          <a:ext cx="2110962" cy="1987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16" name="Prism 8" r:id="rId16" imgW="2867761" imgH="2698634" progId="Prism8.Document">
                  <p:embed/>
                </p:oleObj>
              </mc:Choice>
              <mc:Fallback>
                <p:oleObj name="Prism 8" r:id="rId16" imgW="2867761" imgH="2698634" progId="Prism8.Document">
                  <p:embed/>
                  <p:pic>
                    <p:nvPicPr>
                      <p:cNvPr id="76" name="Object 75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747038" y="2499721"/>
                        <a:ext cx="2110962" cy="1987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Box 59"/>
          <p:cNvSpPr txBox="1"/>
          <p:nvPr/>
        </p:nvSpPr>
        <p:spPr>
          <a:xfrm>
            <a:off x="80335" y="4926780"/>
            <a:ext cx="271057" cy="310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e</a:t>
            </a:r>
            <a:endParaRPr lang="en-GB" sz="1400" b="1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-146568" y="6032877"/>
            <a:ext cx="8885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Ki67-PECy7</a:t>
            </a:r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id="{9826F460-54CD-0347-8360-360DA436FB37}"/>
              </a:ext>
            </a:extLst>
          </p:cNvPr>
          <p:cNvGrpSpPr/>
          <p:nvPr/>
        </p:nvGrpSpPr>
        <p:grpSpPr>
          <a:xfrm>
            <a:off x="390189" y="5175846"/>
            <a:ext cx="4126959" cy="2000467"/>
            <a:chOff x="2374451" y="950878"/>
            <a:chExt cx="7055299" cy="4804628"/>
          </a:xfrm>
        </p:grpSpPr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D2FD5783-AB17-F443-9DD3-25C2EBB9B050}"/>
                </a:ext>
              </a:extLst>
            </p:cNvPr>
            <p:cNvCxnSpPr/>
            <p:nvPr/>
          </p:nvCxnSpPr>
          <p:spPr>
            <a:xfrm>
              <a:off x="2374451" y="5755506"/>
              <a:ext cx="705529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FA41A0F5-DE36-284F-9D86-BD338CA78DAD}"/>
                </a:ext>
              </a:extLst>
            </p:cNvPr>
            <p:cNvCxnSpPr/>
            <p:nvPr/>
          </p:nvCxnSpPr>
          <p:spPr>
            <a:xfrm flipV="1">
              <a:off x="2378566" y="950878"/>
              <a:ext cx="0" cy="48046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Box 78"/>
          <p:cNvSpPr txBox="1"/>
          <p:nvPr/>
        </p:nvSpPr>
        <p:spPr>
          <a:xfrm>
            <a:off x="2222270" y="7175042"/>
            <a:ext cx="5529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FSC-A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635734" y="5002778"/>
            <a:ext cx="6126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Control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619343" y="4992068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1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622099" y="5002138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3</a:t>
            </a:r>
          </a:p>
        </p:txBody>
      </p:sp>
      <p:sp>
        <p:nvSpPr>
          <p:cNvPr id="83" name="TextBox 82"/>
          <p:cNvSpPr txBox="1"/>
          <p:nvPr/>
        </p:nvSpPr>
        <p:spPr>
          <a:xfrm rot="5400000">
            <a:off x="4217218" y="6557639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14 </a:t>
            </a:r>
          </a:p>
        </p:txBody>
      </p:sp>
      <p:sp>
        <p:nvSpPr>
          <p:cNvPr id="84" name="TextBox 83"/>
          <p:cNvSpPr txBox="1"/>
          <p:nvPr/>
        </p:nvSpPr>
        <p:spPr>
          <a:xfrm rot="5400000">
            <a:off x="4217218" y="5611192"/>
            <a:ext cx="5813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Day 7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620721" y="5002778"/>
            <a:ext cx="709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+ gRNA 2</a:t>
            </a:r>
          </a:p>
        </p:txBody>
      </p:sp>
      <p:graphicFrame>
        <p:nvGraphicFramePr>
          <p:cNvPr id="94" name="Object 93"/>
          <p:cNvGraphicFramePr>
            <a:graphicFrameLocks noChangeAspect="1"/>
          </p:cNvGraphicFramePr>
          <p:nvPr>
            <p:extLst/>
          </p:nvPr>
        </p:nvGraphicFramePr>
        <p:xfrm>
          <a:off x="129248" y="7403297"/>
          <a:ext cx="3297583" cy="198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17" name="Prism 8" r:id="rId18" imgW="4477567" imgH="2698634" progId="Prism8.Document">
                  <p:embed/>
                </p:oleObj>
              </mc:Choice>
              <mc:Fallback>
                <p:oleObj name="Prism 8" r:id="rId18" imgW="4477567" imgH="2698634" progId="Prism8.Document">
                  <p:embed/>
                  <p:pic>
                    <p:nvPicPr>
                      <p:cNvPr id="94" name="Object 93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29248" y="7403297"/>
                        <a:ext cx="3297583" cy="198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5" name="TextBox 94"/>
          <p:cNvSpPr txBox="1"/>
          <p:nvPr/>
        </p:nvSpPr>
        <p:spPr>
          <a:xfrm>
            <a:off x="114020" y="7237756"/>
            <a:ext cx="271057" cy="310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f</a:t>
            </a:r>
            <a:endParaRPr lang="en-GB" sz="1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7467" y="5176180"/>
            <a:ext cx="1043568" cy="1026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364477" y="5176514"/>
            <a:ext cx="1043568" cy="1026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367194" y="5176180"/>
            <a:ext cx="1043568" cy="1026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368075" y="5169852"/>
            <a:ext cx="1043568" cy="1026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60734" y="6159835"/>
            <a:ext cx="1043568" cy="1026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364685" y="6159501"/>
            <a:ext cx="1043568" cy="1026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368874" y="6158985"/>
            <a:ext cx="1043568" cy="1026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364333" y="6159453"/>
            <a:ext cx="1043568" cy="102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68718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1168" y="394127"/>
            <a:ext cx="6291072" cy="42165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/>
            <a:r>
              <a:rPr lang="en-GB" sz="1200" b="1" dirty="0">
                <a:solidFill>
                  <a:prstClr val="black"/>
                </a:solidFill>
              </a:rPr>
              <a:t>Supplementary Figure 5. </a:t>
            </a:r>
            <a:r>
              <a:rPr lang="en-GB" sz="1200" b="1" i="1" dirty="0">
                <a:solidFill>
                  <a:prstClr val="black"/>
                </a:solidFill>
              </a:rPr>
              <a:t>Cdkn2a </a:t>
            </a:r>
            <a:r>
              <a:rPr lang="en-GB" sz="1200" b="1" dirty="0">
                <a:solidFill>
                  <a:prstClr val="black"/>
                </a:solidFill>
              </a:rPr>
              <a:t>knockdown in TC expressing endothelial cells allows bypass of growth arrest.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a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Normalised cell number in </a:t>
            </a:r>
            <a:r>
              <a:rPr lang="en-GB" sz="1200" i="1" dirty="0">
                <a:solidFill>
                  <a:prstClr val="black"/>
                </a:solidFill>
              </a:rPr>
              <a:t>Cdkn2a</a:t>
            </a:r>
            <a:r>
              <a:rPr lang="en-GB" sz="1200" dirty="0">
                <a:solidFill>
                  <a:prstClr val="black"/>
                </a:solidFill>
              </a:rPr>
              <a:t> knockout endothelial cells, treated or not with dox, over 14 days, using gRNA 1. Statistical significance was calculated with a two-way ANOVA and Sidak’s multiple comparisons test, n=4.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b</a:t>
            </a:r>
            <a:r>
              <a:rPr lang="en-GB" sz="1200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Normalised cell number in </a:t>
            </a:r>
            <a:r>
              <a:rPr lang="en-GB" sz="1200" i="1" dirty="0">
                <a:solidFill>
                  <a:prstClr val="black"/>
                </a:solidFill>
              </a:rPr>
              <a:t>Cdkn2a</a:t>
            </a:r>
            <a:r>
              <a:rPr lang="en-GB" sz="1200" dirty="0">
                <a:solidFill>
                  <a:prstClr val="black"/>
                </a:solidFill>
              </a:rPr>
              <a:t> knockout endothelial cells, treated or not with dox, over 14 days, using gRNA 3. Statistical significance was calculated with a two-way ANOVA and Sidak’s multiple comparisons test, n=4. P-values for </a:t>
            </a:r>
            <a:r>
              <a:rPr lang="en-GB" sz="1200" b="1" dirty="0">
                <a:solidFill>
                  <a:prstClr val="black"/>
                </a:solidFill>
              </a:rPr>
              <a:t>a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and </a:t>
            </a:r>
            <a:r>
              <a:rPr lang="en-GB" sz="1200" b="1" dirty="0">
                <a:solidFill>
                  <a:prstClr val="black"/>
                </a:solidFill>
              </a:rPr>
              <a:t>b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are outlined in Supplementary Table 1. </a:t>
            </a: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c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Representative flow cytometry plots showing Ki67 expression within the TC high population against FSC-A at day 7 and 14 after </a:t>
            </a:r>
            <a:r>
              <a:rPr lang="en-GB" sz="1200" i="1" dirty="0">
                <a:solidFill>
                  <a:prstClr val="black"/>
                </a:solidFill>
              </a:rPr>
              <a:t>Cdkn2a </a:t>
            </a:r>
            <a:r>
              <a:rPr lang="en-GB" sz="1200" dirty="0">
                <a:solidFill>
                  <a:prstClr val="black"/>
                </a:solidFill>
              </a:rPr>
              <a:t>knockout or not.</a:t>
            </a:r>
            <a:endParaRPr lang="en-GB" sz="1200" b="1" dirty="0">
              <a:solidFill>
                <a:prstClr val="black"/>
              </a:solidFill>
            </a:endParaRP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d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Fold change of Ki67 expression within the TC high population between days 7 and 14 after addition of dox in comparison to uninduced, </a:t>
            </a:r>
            <a:r>
              <a:rPr lang="en-GB" sz="1200" i="1" dirty="0">
                <a:solidFill>
                  <a:prstClr val="black"/>
                </a:solidFill>
              </a:rPr>
              <a:t>Cdkn2a </a:t>
            </a:r>
            <a:r>
              <a:rPr lang="en-GB" sz="1200" dirty="0">
                <a:solidFill>
                  <a:prstClr val="black"/>
                </a:solidFill>
              </a:rPr>
              <a:t>knockout endothelial cells, n=4. Statistical significance was calculated with a two-way ANOVA and Sidak’s multiple comparisons test. </a:t>
            </a:r>
            <a:endParaRPr lang="en-GB" sz="1200" b="1" dirty="0">
              <a:solidFill>
                <a:prstClr val="black"/>
              </a:solidFill>
            </a:endParaRPr>
          </a:p>
          <a:p>
            <a:pPr lvl="0"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e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Representative flow cytometry plots showing Ki67 expression within the uninduced endothelial cell population against FSC-A at day 7 and 14 after </a:t>
            </a:r>
            <a:r>
              <a:rPr lang="en-GB" sz="1200" i="1" dirty="0">
                <a:solidFill>
                  <a:prstClr val="black"/>
                </a:solidFill>
              </a:rPr>
              <a:t>Cdkn2a </a:t>
            </a:r>
            <a:r>
              <a:rPr lang="en-GB" sz="1200" dirty="0">
                <a:solidFill>
                  <a:prstClr val="black"/>
                </a:solidFill>
              </a:rPr>
              <a:t>knockout or not.</a:t>
            </a:r>
          </a:p>
          <a:p>
            <a:pPr algn="just" defTabSz="914400">
              <a:defRPr/>
            </a:pPr>
            <a:r>
              <a:rPr lang="en-GB" sz="1200" b="1" dirty="0">
                <a:solidFill>
                  <a:prstClr val="black"/>
                </a:solidFill>
              </a:rPr>
              <a:t>f</a:t>
            </a:r>
            <a:r>
              <a:rPr lang="en-GB" sz="1200" b="1" dirty="0" smtClean="0">
                <a:solidFill>
                  <a:prstClr val="black"/>
                </a:solidFill>
              </a:rPr>
              <a:t> </a:t>
            </a:r>
            <a:r>
              <a:rPr lang="en-GB" sz="1200" dirty="0">
                <a:solidFill>
                  <a:prstClr val="black"/>
                </a:solidFill>
              </a:rPr>
              <a:t>Fold change of Ki67 expression within the uninduced endothelial cell population between days 7 and 14 after addition of dox in comparison to uninduced endothelial cells, n=4. Statistical significance was calculated with a two-way ANOVA and Sidak’s multiple comparisons test. </a:t>
            </a:r>
            <a:r>
              <a:rPr lang="en-GB" sz="1200" dirty="0"/>
              <a:t>In all panels error bars show SEM, and *p&lt;0.05, **p&lt;0.01, ***p&lt;0.001, ****p&lt;0.0001.</a:t>
            </a:r>
          </a:p>
          <a:p>
            <a:pPr lvl="0" algn="just" defTabSz="914400">
              <a:defRPr/>
            </a:pPr>
            <a:endParaRPr lang="en-GB" sz="1200" dirty="0">
              <a:solidFill>
                <a:prstClr val="black"/>
              </a:solidFill>
            </a:endParaRPr>
          </a:p>
          <a:p>
            <a:pPr lvl="0" defTabSz="914400">
              <a:defRPr/>
            </a:pPr>
            <a:endParaRPr lang="en-GB" sz="1200" b="1" dirty="0">
              <a:solidFill>
                <a:prstClr val="black"/>
              </a:solidFill>
            </a:endParaRPr>
          </a:p>
          <a:p>
            <a:pPr lvl="0" defTabSz="914400"/>
            <a:endParaRPr lang="en-GB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8281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78221" y="764330"/>
          <a:ext cx="4242664" cy="341038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16615">
                  <a:extLst>
                    <a:ext uri="{9D8B030D-6E8A-4147-A177-3AD203B41FA5}">
                      <a16:colId xmlns:a16="http://schemas.microsoft.com/office/drawing/2014/main" val="166703529"/>
                    </a:ext>
                  </a:extLst>
                </a:gridCol>
                <a:gridCol w="983580">
                  <a:extLst>
                    <a:ext uri="{9D8B030D-6E8A-4147-A177-3AD203B41FA5}">
                      <a16:colId xmlns:a16="http://schemas.microsoft.com/office/drawing/2014/main" val="2133440504"/>
                    </a:ext>
                  </a:extLst>
                </a:gridCol>
                <a:gridCol w="957922">
                  <a:extLst>
                    <a:ext uri="{9D8B030D-6E8A-4147-A177-3AD203B41FA5}">
                      <a16:colId xmlns:a16="http://schemas.microsoft.com/office/drawing/2014/main" val="1061641023"/>
                    </a:ext>
                  </a:extLst>
                </a:gridCol>
                <a:gridCol w="984547">
                  <a:extLst>
                    <a:ext uri="{9D8B030D-6E8A-4147-A177-3AD203B41FA5}">
                      <a16:colId xmlns:a16="http://schemas.microsoft.com/office/drawing/2014/main" val="2780606312"/>
                    </a:ext>
                  </a:extLst>
                </a:gridCol>
              </a:tblGrid>
              <a:tr h="262337">
                <a:tc>
                  <a:txBody>
                    <a:bodyPr/>
                    <a:lstStyle/>
                    <a:p>
                      <a:endParaRPr lang="en-GB" sz="1100" dirty="0"/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Day 7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Day 10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Day</a:t>
                      </a:r>
                      <a:r>
                        <a:rPr lang="en-GB" sz="1100" baseline="0" dirty="0"/>
                        <a:t> 14</a:t>
                      </a:r>
                      <a:endParaRPr lang="en-GB" sz="1100" dirty="0"/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518334"/>
                  </a:ext>
                </a:extLst>
              </a:tr>
              <a:tr h="262337">
                <a:tc gridSpan="4">
                  <a:txBody>
                    <a:bodyPr/>
                    <a:lstStyle/>
                    <a:p>
                      <a:r>
                        <a:rPr lang="en-GB" sz="1100" dirty="0"/>
                        <a:t>gRNA 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6915237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–do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10 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96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89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0215432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+dox gRNA</a:t>
                      </a:r>
                      <a:r>
                        <a:rPr lang="en-GB" sz="1100" baseline="0" dirty="0"/>
                        <a:t>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16 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7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06 ***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3502172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</a:t>
                      </a:r>
                      <a:r>
                        <a:rPr lang="en-GB" sz="1100" baseline="0" dirty="0"/>
                        <a:t> –dox gRNA 1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04 *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87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626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4960557"/>
                  </a:ext>
                </a:extLst>
              </a:tr>
              <a:tr h="262337">
                <a:tc grid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gRNA 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369684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–do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&lt;0.0001 **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&gt;0.99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999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1535306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+dox gRNA</a:t>
                      </a:r>
                      <a:r>
                        <a:rPr lang="en-GB" sz="1100" baseline="0" dirty="0"/>
                        <a:t>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&lt;0.0001 **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&lt;0.0001 **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&lt;0.0001 ****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0967772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</a:t>
                      </a:r>
                      <a:r>
                        <a:rPr lang="en-GB" sz="1100" baseline="0" dirty="0"/>
                        <a:t> –dox gRNA 2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04</a:t>
                      </a:r>
                      <a:r>
                        <a:rPr lang="en-GB" sz="1100" baseline="0" dirty="0"/>
                        <a:t> ***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80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873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5864116"/>
                  </a:ext>
                </a:extLst>
              </a:tr>
              <a:tr h="262337">
                <a:tc gridSpan="4">
                  <a:txBody>
                    <a:bodyPr/>
                    <a:lstStyle/>
                    <a:p>
                      <a:r>
                        <a:rPr lang="en-GB" sz="1100" dirty="0"/>
                        <a:t>gRNA 3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3371590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–do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25 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97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91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3675341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 +dox gRNA</a:t>
                      </a:r>
                      <a:r>
                        <a:rPr lang="en-GB" sz="1100" baseline="0" dirty="0"/>
                        <a:t>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0.0381 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0.08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0.0145 *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1558389"/>
                  </a:ext>
                </a:extLst>
              </a:tr>
              <a:tr h="262337">
                <a:tc>
                  <a:txBody>
                    <a:bodyPr/>
                    <a:lstStyle/>
                    <a:p>
                      <a:r>
                        <a:rPr lang="en-GB" sz="1100" dirty="0"/>
                        <a:t>+dox v</a:t>
                      </a:r>
                      <a:r>
                        <a:rPr lang="en-GB" sz="1100" baseline="0" dirty="0"/>
                        <a:t> –dox gRNA 3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0060 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99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.71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8812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4020" y="82936"/>
            <a:ext cx="3671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Table 1</a:t>
            </a:r>
          </a:p>
        </p:txBody>
      </p:sp>
      <p:sp>
        <p:nvSpPr>
          <p:cNvPr id="3" name="Rectangle 2"/>
          <p:cNvSpPr/>
          <p:nvPr/>
        </p:nvSpPr>
        <p:spPr>
          <a:xfrm>
            <a:off x="530352" y="4491335"/>
            <a:ext cx="5705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P-values for normalised cell counts in </a:t>
            </a:r>
            <a:r>
              <a:rPr lang="en-GB" b="1" i="1" dirty="0"/>
              <a:t>Cdkn2a </a:t>
            </a:r>
            <a:r>
              <a:rPr lang="en-GB" b="1" dirty="0"/>
              <a:t>knockout experiments. </a:t>
            </a:r>
          </a:p>
        </p:txBody>
      </p:sp>
    </p:spTree>
    <p:extLst>
      <p:ext uri="{BB962C8B-B14F-4D97-AF65-F5344CB8AC3E}">
        <p14:creationId xmlns:p14="http://schemas.microsoft.com/office/powerpoint/2010/main" val="3436440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523001" y="894478"/>
          <a:ext cx="5915024" cy="4978384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19614">
                  <a:extLst>
                    <a:ext uri="{9D8B030D-6E8A-4147-A177-3AD203B41FA5}">
                      <a16:colId xmlns:a16="http://schemas.microsoft.com/office/drawing/2014/main" val="462301428"/>
                    </a:ext>
                  </a:extLst>
                </a:gridCol>
                <a:gridCol w="892755">
                  <a:extLst>
                    <a:ext uri="{9D8B030D-6E8A-4147-A177-3AD203B41FA5}">
                      <a16:colId xmlns:a16="http://schemas.microsoft.com/office/drawing/2014/main" val="2743292021"/>
                    </a:ext>
                  </a:extLst>
                </a:gridCol>
                <a:gridCol w="1213785">
                  <a:extLst>
                    <a:ext uri="{9D8B030D-6E8A-4147-A177-3AD203B41FA5}">
                      <a16:colId xmlns:a16="http://schemas.microsoft.com/office/drawing/2014/main" val="1922083480"/>
                    </a:ext>
                  </a:extLst>
                </a:gridCol>
                <a:gridCol w="984735">
                  <a:extLst>
                    <a:ext uri="{9D8B030D-6E8A-4147-A177-3AD203B41FA5}">
                      <a16:colId xmlns:a16="http://schemas.microsoft.com/office/drawing/2014/main" val="1618916191"/>
                    </a:ext>
                  </a:extLst>
                </a:gridCol>
                <a:gridCol w="1059883">
                  <a:extLst>
                    <a:ext uri="{9D8B030D-6E8A-4147-A177-3AD203B41FA5}">
                      <a16:colId xmlns:a16="http://schemas.microsoft.com/office/drawing/2014/main" val="789206016"/>
                    </a:ext>
                  </a:extLst>
                </a:gridCol>
                <a:gridCol w="1044252">
                  <a:extLst>
                    <a:ext uri="{9D8B030D-6E8A-4147-A177-3AD203B41FA5}">
                      <a16:colId xmlns:a16="http://schemas.microsoft.com/office/drawing/2014/main" val="2473757389"/>
                    </a:ext>
                  </a:extLst>
                </a:gridCol>
              </a:tblGrid>
              <a:tr h="22003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arge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Species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luoroch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Dilution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pplicatio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Manufacturer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80596"/>
                  </a:ext>
                </a:extLst>
              </a:tr>
              <a:tr h="211616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Primar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3724454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/mous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Sigm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865011697"/>
                  </a:ext>
                </a:extLst>
              </a:tr>
              <a:tr h="31742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γH2AX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2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Cell Signalling Technologies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161499085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D5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Mous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5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nvitroge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1086219371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BRCA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75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nvitroge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71442758"/>
                  </a:ext>
                </a:extLst>
              </a:tr>
              <a:tr h="31742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1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1099519466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-loops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Mous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Unconjugate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5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80730242"/>
                  </a:ext>
                </a:extLst>
              </a:tr>
              <a:tr h="33966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K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ECy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200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 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ell sort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BioLege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169318025"/>
                  </a:ext>
                </a:extLst>
              </a:tr>
              <a:tr h="33966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TIE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200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 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ell sort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Bioscien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67151042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D14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P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Bioscien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2588471859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D3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erCP-Cy5.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BioLege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1904592307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E, BV42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8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BioLege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513072885"/>
                  </a:ext>
                </a:extLst>
              </a:tr>
              <a:tr h="33966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γH2AX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P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4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ell Signalling Technologie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68509452"/>
                  </a:ext>
                </a:extLst>
              </a:tr>
              <a:tr h="21341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Ki6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PECy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1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eBioscien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1385340449"/>
                  </a:ext>
                </a:extLst>
              </a:tr>
              <a:tr h="217027">
                <a:tc gridSpan="6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Secondar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274036"/>
                  </a:ext>
                </a:extLst>
              </a:tr>
              <a:tr h="31742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Go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lexa Fluor 6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800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low cytomet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nvitroge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465623033"/>
                  </a:ext>
                </a:extLst>
              </a:tr>
              <a:tr h="21702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abbit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Goat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lexa Fluor Plus 55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8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nvitroge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259317216"/>
                  </a:ext>
                </a:extLst>
              </a:tr>
              <a:tr h="21702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Mouse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Go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lexa Fluor 6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8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nvitroge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890069132"/>
                  </a:ext>
                </a:extLst>
              </a:tr>
              <a:tr h="21702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Mouse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Goat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lexa Fluor 55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:8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I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Invitrogen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28" marR="64928" marT="0" marB="0"/>
                </a:tc>
                <a:extLst>
                  <a:ext uri="{0D108BD9-81ED-4DB2-BD59-A6C34878D82A}">
                    <a16:rowId xmlns:a16="http://schemas.microsoft.com/office/drawing/2014/main" val="3201934039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596212" y="6880749"/>
          <a:ext cx="5889625" cy="79375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15010">
                  <a:extLst>
                    <a:ext uri="{9D8B030D-6E8A-4147-A177-3AD203B41FA5}">
                      <a16:colId xmlns:a16="http://schemas.microsoft.com/office/drawing/2014/main" val="2678065157"/>
                    </a:ext>
                  </a:extLst>
                </a:gridCol>
                <a:gridCol w="721995">
                  <a:extLst>
                    <a:ext uri="{9D8B030D-6E8A-4147-A177-3AD203B41FA5}">
                      <a16:colId xmlns:a16="http://schemas.microsoft.com/office/drawing/2014/main" val="2346026286"/>
                    </a:ext>
                  </a:extLst>
                </a:gridCol>
                <a:gridCol w="2430780">
                  <a:extLst>
                    <a:ext uri="{9D8B030D-6E8A-4147-A177-3AD203B41FA5}">
                      <a16:colId xmlns:a16="http://schemas.microsoft.com/office/drawing/2014/main" val="317915943"/>
                    </a:ext>
                  </a:extLst>
                </a:gridCol>
                <a:gridCol w="2021840">
                  <a:extLst>
                    <a:ext uri="{9D8B030D-6E8A-4147-A177-3AD203B41FA5}">
                      <a16:colId xmlns:a16="http://schemas.microsoft.com/office/drawing/2014/main" val="2560222098"/>
                    </a:ext>
                  </a:extLst>
                </a:gridCol>
              </a:tblGrid>
              <a:tr h="2311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gRNA #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Targe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Sequenc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anufacture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2274693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kn2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GAGCTGAAGCTATGCCCG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ntegrated DNA Technolog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33634610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kn2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GGAAGGCTTCCTGGACACG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ntegrated DNA Technolog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94890133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kn2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GGGAACGTCGCCCAGACCGA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ated DNA Technologie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33057114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14020" y="82936"/>
            <a:ext cx="67439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Table 2: </a:t>
            </a:r>
            <a:r>
              <a:rPr lang="en-GB" dirty="0" smtClean="0"/>
              <a:t>Antibodies </a:t>
            </a:r>
            <a:r>
              <a:rPr lang="en-GB" dirty="0"/>
              <a:t>used for immunofluorescence and flow cytometry </a:t>
            </a:r>
            <a:r>
              <a:rPr lang="en-GB" dirty="0" smtClean="0"/>
              <a:t>experiments</a:t>
            </a:r>
            <a:endParaRPr lang="en-GB" sz="2400" dirty="0"/>
          </a:p>
          <a:p>
            <a:endParaRPr lang="en-GB" sz="2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14020" y="6145973"/>
            <a:ext cx="66315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Table </a:t>
            </a:r>
            <a:r>
              <a:rPr lang="en-GB" b="1" dirty="0"/>
              <a:t>3</a:t>
            </a:r>
            <a:r>
              <a:rPr lang="en-GB" b="1" dirty="0" smtClean="0"/>
              <a:t>: </a:t>
            </a:r>
            <a:r>
              <a:rPr lang="en-GB" dirty="0"/>
              <a:t>Sequences of guide RNA used for CRISPR/Cas9 knockout of </a:t>
            </a:r>
            <a:r>
              <a:rPr lang="en-GB" i="1" dirty="0"/>
              <a:t>Cdkn2a. </a:t>
            </a:r>
            <a:r>
              <a:rPr lang="en-GB" dirty="0" smtClean="0"/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66110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85</TotalTime>
  <Words>1418</Words>
  <Application>Microsoft Office PowerPoint</Application>
  <PresentationFormat>A4 Paper (210x297 mm)</PresentationFormat>
  <Paragraphs>313</Paragraphs>
  <Slides>9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Neil</dc:creator>
  <cp:lastModifiedBy>Valerie Kouskoff</cp:lastModifiedBy>
  <cp:revision>278</cp:revision>
  <dcterms:created xsi:type="dcterms:W3CDTF">2022-01-27T08:47:04Z</dcterms:created>
  <dcterms:modified xsi:type="dcterms:W3CDTF">2022-10-07T07:50:26Z</dcterms:modified>
</cp:coreProperties>
</file>